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196BE3-1ED3-4334-802C-29BD20C6931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304B1B-21A9-4B4E-AFD6-177AA03CEC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6BCE52-FB9E-4713-AC41-B04CAB7C7E2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59D34D-FDF8-4437-AE65-A8384DE5288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7AD962-4339-4108-B3AE-DBF9C10DEAE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AF1FB9-2C9F-4C41-80CF-B4F9A0F4D99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70212B-324D-4949-A4B4-B28B7E066F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DB3087-EC16-476F-B8E1-76F0BC34796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15FDE5-F335-48DD-9D2D-27AF7DABEE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CBDACD-37B6-4C05-877D-19B471009B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BBE670-032E-4768-96A5-675607C634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69E860-2597-4934-AD95-AACF988C6C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1C6E7D6-66D6-4499-8894-BBFFEE6044C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7"/>
          <p:cNvGrpSpPr/>
          <p:nvPr/>
        </p:nvGrpSpPr>
        <p:grpSpPr>
          <a:xfrm>
            <a:off x="1473120" y="887400"/>
            <a:ext cx="5613480" cy="1714320"/>
            <a:chOff x="1473120" y="887400"/>
            <a:chExt cx="5613480" cy="1714320"/>
          </a:xfrm>
        </p:grpSpPr>
        <p:grpSp>
          <p:nvGrpSpPr>
            <p:cNvPr id="42" name="Group 19"/>
            <p:cNvGrpSpPr/>
            <p:nvPr/>
          </p:nvGrpSpPr>
          <p:grpSpPr>
            <a:xfrm>
              <a:off x="1473120" y="887400"/>
              <a:ext cx="5155920" cy="227520"/>
              <a:chOff x="1473120" y="887400"/>
              <a:chExt cx="5155920" cy="227520"/>
            </a:xfrm>
          </p:grpSpPr>
          <p:grpSp>
            <p:nvGrpSpPr>
              <p:cNvPr id="43" name="Group 4"/>
              <p:cNvGrpSpPr/>
              <p:nvPr/>
            </p:nvGrpSpPr>
            <p:grpSpPr>
              <a:xfrm>
                <a:off x="1903320" y="887400"/>
                <a:ext cx="4725720" cy="227520"/>
                <a:chOff x="1903320" y="887400"/>
                <a:chExt cx="4725720" cy="227520"/>
              </a:xfrm>
            </p:grpSpPr>
            <p:sp>
              <p:nvSpPr>
                <p:cNvPr id="44" name="Text Box 6"/>
                <p:cNvSpPr/>
                <p:nvPr/>
              </p:nvSpPr>
              <p:spPr>
                <a:xfrm>
                  <a:off x="1903320" y="889200"/>
                  <a:ext cx="520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E3/E3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" name="Text Box 7"/>
                <p:cNvSpPr/>
                <p:nvPr/>
              </p:nvSpPr>
              <p:spPr>
                <a:xfrm>
                  <a:off x="2282400" y="899280"/>
                  <a:ext cx="520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E2/E4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" name="Text Box 8"/>
                <p:cNvSpPr/>
                <p:nvPr/>
              </p:nvSpPr>
              <p:spPr>
                <a:xfrm>
                  <a:off x="2661840" y="887400"/>
                  <a:ext cx="520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E3/E4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" name="Text Box 9"/>
                <p:cNvSpPr/>
                <p:nvPr/>
              </p:nvSpPr>
              <p:spPr>
                <a:xfrm>
                  <a:off x="3030480" y="897480"/>
                  <a:ext cx="520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E2/E4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" name="Text Box 10"/>
                <p:cNvSpPr/>
                <p:nvPr/>
              </p:nvSpPr>
              <p:spPr>
                <a:xfrm>
                  <a:off x="3409920" y="897480"/>
                  <a:ext cx="520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E3/E3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" name="Text Box 11"/>
                <p:cNvSpPr/>
                <p:nvPr/>
              </p:nvSpPr>
              <p:spPr>
                <a:xfrm>
                  <a:off x="3789360" y="897480"/>
                  <a:ext cx="520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E3/E3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" name="Text Box 12"/>
                <p:cNvSpPr/>
                <p:nvPr/>
              </p:nvSpPr>
              <p:spPr>
                <a:xfrm>
                  <a:off x="4146840" y="897480"/>
                  <a:ext cx="520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E3/E3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" name="Text Box 13"/>
                <p:cNvSpPr/>
                <p:nvPr/>
              </p:nvSpPr>
              <p:spPr>
                <a:xfrm>
                  <a:off x="4526280" y="897480"/>
                  <a:ext cx="520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E3/E3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" name="Text Box 14"/>
                <p:cNvSpPr/>
                <p:nvPr/>
              </p:nvSpPr>
              <p:spPr>
                <a:xfrm>
                  <a:off x="4916160" y="897480"/>
                  <a:ext cx="520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E3/E4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Text Box 15"/>
                <p:cNvSpPr/>
                <p:nvPr/>
              </p:nvSpPr>
              <p:spPr>
                <a:xfrm>
                  <a:off x="5317560" y="897480"/>
                  <a:ext cx="520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E3/E3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Text Box 16"/>
                <p:cNvSpPr/>
                <p:nvPr/>
              </p:nvSpPr>
              <p:spPr>
                <a:xfrm>
                  <a:off x="5696640" y="897480"/>
                  <a:ext cx="520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E2/E3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Text Box 17"/>
                <p:cNvSpPr/>
                <p:nvPr/>
              </p:nvSpPr>
              <p:spPr>
                <a:xfrm>
                  <a:off x="6108840" y="897480"/>
                  <a:ext cx="520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E3/E4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6" name="Text Box 18"/>
              <p:cNvSpPr/>
              <p:nvPr/>
            </p:nvSpPr>
            <p:spPr>
              <a:xfrm>
                <a:off x="1473120" y="888840"/>
                <a:ext cx="533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Ladder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7" name="Text Box 20"/>
            <p:cNvSpPr/>
            <p:nvPr/>
          </p:nvSpPr>
          <p:spPr>
            <a:xfrm>
              <a:off x="6553080" y="1309680"/>
              <a:ext cx="533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91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21"/>
            <p:cNvSpPr/>
            <p:nvPr/>
          </p:nvSpPr>
          <p:spPr>
            <a:xfrm>
              <a:off x="6553080" y="1409760"/>
              <a:ext cx="457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83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22"/>
            <p:cNvSpPr/>
            <p:nvPr/>
          </p:nvSpPr>
          <p:spPr>
            <a:xfrm>
              <a:off x="6553080" y="1519200"/>
              <a:ext cx="533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72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23"/>
            <p:cNvSpPr/>
            <p:nvPr/>
          </p:nvSpPr>
          <p:spPr>
            <a:xfrm>
              <a:off x="6553080" y="1843200"/>
              <a:ext cx="533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48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24"/>
            <p:cNvSpPr/>
            <p:nvPr/>
          </p:nvSpPr>
          <p:spPr>
            <a:xfrm>
              <a:off x="6553080" y="2157480"/>
              <a:ext cx="457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35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25"/>
            <p:cNvSpPr/>
            <p:nvPr/>
          </p:nvSpPr>
          <p:spPr>
            <a:xfrm>
              <a:off x="6553080" y="2286000"/>
              <a:ext cx="457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33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26"/>
            <p:cNvSpPr/>
            <p:nvPr/>
          </p:nvSpPr>
          <p:spPr>
            <a:xfrm>
              <a:off x="6553080" y="2386080"/>
              <a:ext cx="457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28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4" name="Text Box 28"/>
          <p:cNvSpPr/>
          <p:nvPr/>
        </p:nvSpPr>
        <p:spPr>
          <a:xfrm>
            <a:off x="1371600" y="3657600"/>
            <a:ext cx="51814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1: Restriction fragment length polymorphism genotyping of ApoE SNPs, 300 base pair nested PCR is digested with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Hha I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nd visualized on 4% agarose ge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Picture 81" descr="ApoE gell picture.tif"/>
          <p:cNvPicPr/>
          <p:nvPr/>
        </p:nvPicPr>
        <p:blipFill>
          <a:blip r:embed="rId1"/>
          <a:stretch/>
        </p:blipFill>
        <p:spPr>
          <a:xfrm>
            <a:off x="1390680" y="1219320"/>
            <a:ext cx="5162400" cy="2209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07T22:25:17Z</dcterms:created>
  <dc:creator>slri</dc:creator>
  <dc:description/>
  <dc:language>en-US</dc:language>
  <cp:lastModifiedBy>rmgzkm3</cp:lastModifiedBy>
  <dcterms:modified xsi:type="dcterms:W3CDTF">2009-04-27T08:57:55Z</dcterms:modified>
  <cp:revision>4</cp:revision>
  <dc:subject/>
  <dc:title>Slide 1</dc:title>
</cp:coreProperties>
</file>